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3312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43279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640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49228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0934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9713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1755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347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85152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041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2372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040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D63728-2728-4746-89D7-414F97CB25B4}" type="datetimeFigureOut">
              <a:rPr lang="zh-CN" altLang="en-US" smtClean="0"/>
              <a:t>2018/12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826C69-91AC-4E2D-A459-F98A9DA640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2280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5" name="Rectangle 1"/>
          <p:cNvSpPr>
            <a:spLocks noChangeArrowheads="1"/>
          </p:cNvSpPr>
          <p:nvPr/>
        </p:nvSpPr>
        <p:spPr bwMode="auto">
          <a:xfrm>
            <a:off x="457200" y="304800"/>
            <a:ext cx="41148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200" b="1" dirty="0" smtClean="0">
                <a:solidFill>
                  <a:srgbClr val="000000"/>
                </a:solidFill>
                <a:latin typeface="Times New Roman"/>
              </a:rPr>
              <a:t>S2 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/>
                <a:ea typeface="SimSun"/>
              </a:rPr>
              <a:t>Table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/>
              </a:rPr>
              <a:t>.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/>
                <a:ea typeface="SimSun"/>
              </a:rPr>
              <a:t> Gene names and </a:t>
            </a:r>
            <a:r>
              <a:rPr lang="en-US" altLang="zh-CN" sz="1200" b="1" dirty="0" err="1" smtClean="0">
                <a:solidFill>
                  <a:srgbClr val="000000"/>
                </a:solidFill>
                <a:latin typeface="Times New Roman"/>
                <a:ea typeface="SimSun"/>
              </a:rPr>
              <a:t>GenBank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/>
                <a:ea typeface="SimSun"/>
              </a:rPr>
              <a:t> reference numbers</a:t>
            </a:r>
            <a:r>
              <a:rPr lang="en-US" altLang="zh-CN" sz="1200" b="1" dirty="0" smtClean="0">
                <a:solidFill>
                  <a:srgbClr val="000000"/>
                </a:solidFill>
                <a:latin typeface="Times New Roman"/>
              </a:rPr>
              <a:t>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533400" y="762000"/>
          <a:ext cx="5715000" cy="3962402"/>
        </p:xfrm>
        <a:graphic>
          <a:graphicData uri="http://schemas.openxmlformats.org/drawingml/2006/table">
            <a:tbl>
              <a:tblPr/>
              <a:tblGrid>
                <a:gridCol w="4532993"/>
                <a:gridCol w="1182007"/>
              </a:tblGrid>
              <a:tr h="284282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Gene name</a:t>
                      </a: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Genbank</a:t>
                      </a: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50966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latin typeface="Times New Roman"/>
                          <a:ea typeface="SimSun"/>
                          <a:cs typeface="Times New Roman"/>
                        </a:rPr>
                        <a:t>Arabidopsis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 i="1">
                          <a:solidFill>
                            <a:srgbClr val="000000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thaliana</a:t>
                      </a:r>
                      <a:r>
                        <a:rPr lang="en-US" sz="1200" i="1">
                          <a:latin typeface="Times New Roman"/>
                          <a:ea typeface="SimSun"/>
                          <a:cs typeface="Times New Roman"/>
                        </a:rPr>
                        <a:t> ribulose bisphosphate carboxylase small subunit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NM202369.2</a:t>
                      </a: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84282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latin typeface="Times New Roman"/>
                          <a:ea typeface="SimSun"/>
                          <a:cs typeface="Times New Roman"/>
                        </a:rPr>
                        <a:t>Solanum lycopersicum linalool synthase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JN408286.1</a:t>
                      </a: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4282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Arabidopsis</a:t>
                      </a: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 i="1" dirty="0">
                          <a:solidFill>
                            <a:srgbClr val="000000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thaliana</a:t>
                      </a: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 i="1" dirty="0" err="1">
                          <a:latin typeface="Times New Roman"/>
                          <a:ea typeface="SimSun"/>
                          <a:cs typeface="Times New Roman"/>
                        </a:rPr>
                        <a:t>farnesyl</a:t>
                      </a: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 i="1" dirty="0" err="1">
                          <a:latin typeface="Times New Roman"/>
                          <a:ea typeface="SimSun"/>
                          <a:cs typeface="Times New Roman"/>
                        </a:rPr>
                        <a:t>diphosphate</a:t>
                      </a: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 i="1" dirty="0" err="1">
                          <a:latin typeface="Times New Roman"/>
                          <a:ea typeface="SimSun"/>
                          <a:cs typeface="Times New Roman"/>
                        </a:rPr>
                        <a:t>synthase</a:t>
                      </a: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U80605.1</a:t>
                      </a: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4282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 err="1">
                          <a:latin typeface="Times New Roman"/>
                          <a:ea typeface="SimSun"/>
                          <a:cs typeface="Times New Roman"/>
                        </a:rPr>
                        <a:t>Santalum</a:t>
                      </a: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 album </a:t>
                      </a:r>
                      <a:r>
                        <a:rPr lang="en-US" sz="1200" i="1" dirty="0" err="1">
                          <a:latin typeface="Times New Roman"/>
                          <a:ea typeface="SimSun"/>
                          <a:cs typeface="Times New Roman"/>
                        </a:rPr>
                        <a:t>santalene</a:t>
                      </a: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 i="1" dirty="0" err="1">
                          <a:latin typeface="Times New Roman"/>
                          <a:ea typeface="SimSun"/>
                          <a:cs typeface="Times New Roman"/>
                        </a:rPr>
                        <a:t>synthase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HQ343276.1</a:t>
                      </a: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68564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Arabidopsis</a:t>
                      </a: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 i="1" dirty="0">
                          <a:solidFill>
                            <a:srgbClr val="000000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thaliana</a:t>
                      </a: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 3-hydroxy-3-methylglutaryl coenzyme A </a:t>
                      </a:r>
                      <a:r>
                        <a:rPr lang="en-US" sz="1200" i="1" dirty="0" err="1">
                          <a:latin typeface="Times New Roman"/>
                          <a:ea typeface="SimSun"/>
                          <a:cs typeface="Times New Roman"/>
                        </a:rPr>
                        <a:t>reductase</a:t>
                      </a: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 i="1" dirty="0" err="1">
                          <a:latin typeface="Times New Roman"/>
                          <a:ea typeface="SimSun"/>
                          <a:cs typeface="Times New Roman"/>
                        </a:rPr>
                        <a:t>isoform</a:t>
                      </a: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 1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Y488113.1</a:t>
                      </a: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68564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Arabidopsis</a:t>
                      </a:r>
                      <a:r>
                        <a:rPr lang="en-US" sz="1200" dirty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 i="1" dirty="0">
                          <a:solidFill>
                            <a:srgbClr val="000000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thaliana</a:t>
                      </a: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 i="1" dirty="0" err="1">
                          <a:latin typeface="Times New Roman"/>
                          <a:ea typeface="SimSun"/>
                          <a:cs typeface="Times New Roman"/>
                        </a:rPr>
                        <a:t>ribulose</a:t>
                      </a: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 1.5-biphoshate </a:t>
                      </a:r>
                      <a:r>
                        <a:rPr lang="en-US" sz="1200" i="1" dirty="0" err="1">
                          <a:latin typeface="Times New Roman"/>
                          <a:ea typeface="SimSun"/>
                          <a:cs typeface="Times New Roman"/>
                        </a:rPr>
                        <a:t>carboxylase</a:t>
                      </a:r>
                      <a:r>
                        <a:rPr lang="en-US" sz="1200" i="1" dirty="0">
                          <a:latin typeface="Times New Roman"/>
                          <a:ea typeface="SimSun"/>
                          <a:cs typeface="Times New Roman"/>
                        </a:rPr>
                        <a:t> small subunit promoter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X13611.1</a:t>
                      </a: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84282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i="1">
                          <a:latin typeface="Times New Roman"/>
                          <a:ea typeface="SimSun"/>
                          <a:cs typeface="Times New Roman"/>
                        </a:rPr>
                        <a:t>Arabidopsis</a:t>
                      </a: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200" i="1">
                          <a:solidFill>
                            <a:srgbClr val="000000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thaliana </a:t>
                      </a:r>
                      <a:r>
                        <a:rPr lang="en-US" sz="1200" i="1">
                          <a:latin typeface="Times New Roman"/>
                          <a:ea typeface="SimSun"/>
                          <a:cs typeface="Times New Roman"/>
                        </a:rPr>
                        <a:t>ubiqutin-10 promoter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At4G05320.2</a:t>
                      </a: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50966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1200" i="1">
                          <a:latin typeface="Times New Roman"/>
                          <a:ea typeface="SimSun"/>
                          <a:cs typeface="Times New Roman"/>
                        </a:rPr>
                        <a:t>Santalum album santalene/bergamotene oxidase SaCYP76F38v1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KC533715</a:t>
                      </a: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50966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1200" i="1">
                          <a:latin typeface="Times New Roman"/>
                          <a:ea typeface="SimSun"/>
                          <a:cs typeface="Times New Roman"/>
                        </a:rPr>
                        <a:t>Santalum album santalene/bergamotene oxidase SaCYP76F42</a:t>
                      </a:r>
                      <a:endParaRPr lang="en-US" sz="12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latin typeface="Times New Roman"/>
                          <a:ea typeface="SimSun"/>
                          <a:cs typeface="Times New Roman"/>
                        </a:rPr>
                        <a:t>KC698965</a:t>
                      </a: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350966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1200" i="1" dirty="0">
                          <a:latin typeface="Times New Roman"/>
                          <a:ea typeface="SimSun"/>
                          <a:cs typeface="Times New Roman"/>
                        </a:rPr>
                        <a:t>Santalum album santalene/bergamotene oxidase SaCYP76F39v1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1200" dirty="0">
                          <a:latin typeface="Times New Roman"/>
                          <a:ea typeface="SimSun"/>
                          <a:cs typeface="Times New Roman"/>
                        </a:rPr>
                        <a:t>KC533716.1</a:t>
                      </a:r>
                      <a:endParaRPr lang="en-US" sz="12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28222" marR="28222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02792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8</Words>
  <Application>Microsoft Office PowerPoint</Application>
  <PresentationFormat>全屏显示(4:3)</PresentationFormat>
  <Paragraphs>2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尹俊林</dc:creator>
  <cp:lastModifiedBy>尹俊林</cp:lastModifiedBy>
  <cp:revision>1</cp:revision>
  <dcterms:created xsi:type="dcterms:W3CDTF">2018-12-27T07:45:28Z</dcterms:created>
  <dcterms:modified xsi:type="dcterms:W3CDTF">2018-12-27T07:46:09Z</dcterms:modified>
</cp:coreProperties>
</file>